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4" autoAdjust="0"/>
    <p:restoredTop sz="94660"/>
  </p:normalViewPr>
  <p:slideViewPr>
    <p:cSldViewPr snapToGrid="0">
      <p:cViewPr varScale="1">
        <p:scale>
          <a:sx n="50" d="100"/>
          <a:sy n="50" d="100"/>
        </p:scale>
        <p:origin x="1690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230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185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101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366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267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421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330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440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66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588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903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7865A-FEF1-47DF-B2A1-19C8CFB155D2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BB5E5-629B-4BA6-ADF0-895D00C2F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321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E35E560-827A-43D4-8AC7-E35B8391E3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3567012"/>
              </p:ext>
            </p:extLst>
          </p:nvPr>
        </p:nvGraphicFramePr>
        <p:xfrm>
          <a:off x="1077913" y="2641600"/>
          <a:ext cx="5099050" cy="3001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9" r:id="rId3" imgW="3742890" imgH="2202408" progId="Prism9.Document">
                  <p:embed/>
                </p:oleObj>
              </mc:Choice>
              <mc:Fallback>
                <p:oleObj name="Prism 9" r:id="rId3" imgW="3742890" imgH="2202408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E35E560-827A-43D4-8AC7-E35B8391E3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7913" y="2641600"/>
                        <a:ext cx="5099050" cy="3001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C1210D3-54EF-43F2-AA44-81C5C349D8F1}"/>
              </a:ext>
            </a:extLst>
          </p:cNvPr>
          <p:cNvSpPr txBox="1"/>
          <p:nvPr/>
        </p:nvSpPr>
        <p:spPr>
          <a:xfrm>
            <a:off x="0" y="0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B2891B08-794B-423B-9470-D30FC6ADAE3F}"/>
              </a:ext>
            </a:extLst>
          </p:cNvPr>
          <p:cNvSpPr/>
          <p:nvPr/>
        </p:nvSpPr>
        <p:spPr>
          <a:xfrm>
            <a:off x="4606290" y="2868930"/>
            <a:ext cx="91440" cy="9144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77C1A24-8E6C-4253-B16A-E5471C7DB25E}"/>
              </a:ext>
            </a:extLst>
          </p:cNvPr>
          <p:cNvSpPr/>
          <p:nvPr/>
        </p:nvSpPr>
        <p:spPr>
          <a:xfrm>
            <a:off x="4606290" y="3079752"/>
            <a:ext cx="91440" cy="91440"/>
          </a:xfrm>
          <a:prstGeom prst="ellipse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C7FEF48-56C1-41BE-91AC-152194E5095B}"/>
              </a:ext>
            </a:extLst>
          </p:cNvPr>
          <p:cNvSpPr txBox="1"/>
          <p:nvPr/>
        </p:nvSpPr>
        <p:spPr>
          <a:xfrm>
            <a:off x="4640735" y="2756897"/>
            <a:ext cx="415498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A4E856-E6FC-438D-A9D6-8B8F4C812057}"/>
              </a:ext>
            </a:extLst>
          </p:cNvPr>
          <p:cNvSpPr txBox="1"/>
          <p:nvPr/>
        </p:nvSpPr>
        <p:spPr>
          <a:xfrm>
            <a:off x="4652010" y="2971029"/>
            <a:ext cx="40588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991F49-2542-46C2-B14A-ED29605AC729}"/>
              </a:ext>
            </a:extLst>
          </p:cNvPr>
          <p:cNvSpPr txBox="1"/>
          <p:nvPr/>
        </p:nvSpPr>
        <p:spPr>
          <a:xfrm>
            <a:off x="1756383" y="5460147"/>
            <a:ext cx="9143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raining phase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1-20 d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D9F066-3812-4265-B7E0-6CBEB22696CA}"/>
              </a:ext>
            </a:extLst>
          </p:cNvPr>
          <p:cNvSpPr txBox="1"/>
          <p:nvPr/>
        </p:nvSpPr>
        <p:spPr>
          <a:xfrm>
            <a:off x="2686048" y="5460147"/>
            <a:ext cx="10819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otshock phase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21-31 d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FA6D57-BF28-457A-90D6-EE198BC119D2}"/>
              </a:ext>
            </a:extLst>
          </p:cNvPr>
          <p:cNvSpPr txBox="1"/>
          <p:nvPr/>
        </p:nvSpPr>
        <p:spPr>
          <a:xfrm>
            <a:off x="3596696" y="5497188"/>
            <a:ext cx="118104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1 Antagonist treatment phase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32-37 d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FA7BF18-108C-4BA1-A6F1-36C7B960C8A2}"/>
              </a:ext>
            </a:extLst>
          </p:cNvPr>
          <p:cNvSpPr txBox="1"/>
          <p:nvPr/>
        </p:nvSpPr>
        <p:spPr>
          <a:xfrm>
            <a:off x="4599040" y="5497188"/>
            <a:ext cx="118104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mergencephas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38-42 d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9DFFF0-D6A8-4A5C-AF9C-3E2346A876A4}"/>
              </a:ext>
            </a:extLst>
          </p:cNvPr>
          <p:cNvSpPr txBox="1"/>
          <p:nvPr/>
        </p:nvSpPr>
        <p:spPr>
          <a:xfrm rot="16200000">
            <a:off x="-252350" y="3968664"/>
            <a:ext cx="25683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ld change in METH intak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relative to training phas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8A33EFE-DD30-49B3-BEFB-567BE4BA20FF}"/>
              </a:ext>
            </a:extLst>
          </p:cNvPr>
          <p:cNvSpPr txBox="1"/>
          <p:nvPr/>
        </p:nvSpPr>
        <p:spPr>
          <a:xfrm>
            <a:off x="1077913" y="6891137"/>
            <a:ext cx="50990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This figure shows  fold changes in METH intake during footshocks, SCH23390 treatment, and cessation of SCH23390 treatment in relation to METH intake during the training period. Student’s t-test was used for comparison of total METH intake between the SR and SS rat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METH intake of SR rats was significantly greater (### p&lt;0.0001, SR vs SS) than that of SS rat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3BC9CE6-2E26-4CCD-A135-B1EE277C5540}"/>
              </a:ext>
            </a:extLst>
          </p:cNvPr>
          <p:cNvSpPr txBox="1"/>
          <p:nvPr/>
        </p:nvSpPr>
        <p:spPr>
          <a:xfrm>
            <a:off x="3104253" y="449780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#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49DC83A-C9A4-4330-AD54-C08C6B482AD2}"/>
              </a:ext>
            </a:extLst>
          </p:cNvPr>
          <p:cNvSpPr txBox="1"/>
          <p:nvPr/>
        </p:nvSpPr>
        <p:spPr>
          <a:xfrm>
            <a:off x="4043462" y="5046435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#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C6FE8D-9ADD-49F9-8DA0-75F2BCC461D0}"/>
              </a:ext>
            </a:extLst>
          </p:cNvPr>
          <p:cNvSpPr txBox="1"/>
          <p:nvPr/>
        </p:nvSpPr>
        <p:spPr>
          <a:xfrm>
            <a:off x="4996848" y="505734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#</a:t>
            </a:r>
          </a:p>
        </p:txBody>
      </p:sp>
    </p:spTree>
    <p:extLst>
      <p:ext uri="{BB962C8B-B14F-4D97-AF65-F5344CB8AC3E}">
        <p14:creationId xmlns:p14="http://schemas.microsoft.com/office/powerpoint/2010/main" val="592845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</TotalTime>
  <Words>116</Words>
  <Application>Microsoft Office PowerPoint</Application>
  <PresentationFormat>Letter Paper (8.5x11 in)</PresentationFormat>
  <Paragraphs>1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anthi, Subramaniam (NIH/NIDA/IRP) [E]</dc:creator>
  <cp:lastModifiedBy>Jayanthi, Subramaniam (NIH/NIDA/IRP) [E]</cp:lastModifiedBy>
  <cp:revision>8</cp:revision>
  <dcterms:created xsi:type="dcterms:W3CDTF">2022-07-27T18:32:16Z</dcterms:created>
  <dcterms:modified xsi:type="dcterms:W3CDTF">2022-09-02T18:21:25Z</dcterms:modified>
</cp:coreProperties>
</file>